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oup 226">
            <a:extLst>
              <a:ext uri="{FF2B5EF4-FFF2-40B4-BE49-F238E27FC236}">
                <a16:creationId xmlns:a16="http://schemas.microsoft.com/office/drawing/2014/main" id="{064948CE-008B-4DFF-B39E-D340677A8D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1369326"/>
              </p:ext>
            </p:extLst>
          </p:nvPr>
        </p:nvGraphicFramePr>
        <p:xfrm>
          <a:off x="406630" y="542233"/>
          <a:ext cx="6839122" cy="6259989"/>
        </p:xfrm>
        <a:graphic>
          <a:graphicData uri="http://schemas.openxmlformats.org/drawingml/2006/table">
            <a:tbl>
              <a:tblPr/>
              <a:tblGrid>
                <a:gridCol w="16296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18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100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979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4426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967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979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4426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2967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51314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eason's  Product-moment correlation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1976" marR="91976" marT="45988" marB="4598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pearman's rank difference correlation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1976" marR="91976" marT="45988" marB="4598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523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1</a:t>
                      </a:r>
                      <a:endParaRPr kumimoji="1" lang="en-US" altLang="ja-JP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2</a:t>
                      </a:r>
                      <a:endParaRPr kumimoji="1" lang="en-US" altLang="ja-JP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n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ｒ</a:t>
                      </a:r>
                      <a:endParaRPr kumimoji="1" lang="ja-JP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1976" marR="91976" marT="45988" marB="4598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ρ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1976" marR="91976" marT="45988" marB="4598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45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43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40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1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6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85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62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46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58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03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97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0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6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25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35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05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5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48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06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7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45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23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2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51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9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52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77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6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7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96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87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50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3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2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40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17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9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3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7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67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5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1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 (days)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0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02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1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68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6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3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1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6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3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4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52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40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5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46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0783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712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05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46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90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2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29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08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0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36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01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1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9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08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09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51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07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7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7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58189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3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72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0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54 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4</a:t>
                      </a:r>
                      <a:endParaRPr kumimoji="1" lang="en-US" altLang="ja-JP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571" marR="89571" marT="44783" marB="4478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DDCB09-0816-4D86-8FDD-C1B9BEB9A666}"/>
              </a:ext>
            </a:extLst>
          </p:cNvPr>
          <p:cNvSpPr txBox="1"/>
          <p:nvPr/>
        </p:nvSpPr>
        <p:spPr>
          <a:xfrm>
            <a:off x="301801" y="12962"/>
            <a:ext cx="671709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. Correlation between serum sCD26/DPP4 titer variation (%) and tumor volume </a:t>
            </a:r>
          </a:p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 or PFS (days) in 14 male cases with Q2W administration by PPMC or SRDC analysis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8045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8</TotalTime>
  <Words>321</Words>
  <Application>Microsoft Office PowerPoint</Application>
  <PresentationFormat>画面に合わせる (4:3)</PresentationFormat>
  <Paragraphs>2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6:34Z</dcterms:modified>
</cp:coreProperties>
</file>